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6" roundtripDataSignature="AMtx7mjg+Yxnm7XRweIUNW0+7cppt9Zfo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4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5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6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7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7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8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8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8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8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159045" y="98855"/>
            <a:ext cx="11287887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8. Number of transposable elements small RNAs in subtelomeric and internal region.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85" name="Google Shape;85;p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417382" y="1894061"/>
            <a:ext cx="3515950" cy="288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6" name="Google Shape;86;p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253675" y="1894061"/>
            <a:ext cx="3515950" cy="2880000"/>
          </a:xfrm>
          <a:prstGeom prst="rect">
            <a:avLst/>
          </a:prstGeom>
          <a:noFill/>
          <a:ln>
            <a:noFill/>
          </a:ln>
        </p:spPr>
      </p:pic>
      <p:sp>
        <p:nvSpPr>
          <p:cNvPr id="87" name="Google Shape;87;p1"/>
          <p:cNvSpPr txBox="1"/>
          <p:nvPr/>
        </p:nvSpPr>
        <p:spPr>
          <a:xfrm>
            <a:off x="3140522" y="4339835"/>
            <a:ext cx="2261700" cy="461700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UY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8" name="Google Shape;88;p1"/>
          <p:cNvSpPr txBox="1"/>
          <p:nvPr/>
        </p:nvSpPr>
        <p:spPr>
          <a:xfrm>
            <a:off x="7314588" y="4339835"/>
            <a:ext cx="2261700" cy="461700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UY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ernal               Subtelomeri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89;p1"/>
          <p:cNvSpPr txBox="1"/>
          <p:nvPr/>
        </p:nvSpPr>
        <p:spPr>
          <a:xfrm>
            <a:off x="3673920" y="1676948"/>
            <a:ext cx="1194900" cy="461700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UY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IRE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7805835" y="1718311"/>
            <a:ext cx="1194900" cy="461700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UY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1Tc</a:t>
            </a:r>
            <a:endParaRPr/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1" name="Google Shape;91;p1"/>
          <p:cNvSpPr txBox="1"/>
          <p:nvPr/>
        </p:nvSpPr>
        <p:spPr>
          <a:xfrm rot="-5400000">
            <a:off x="1568646" y="3077724"/>
            <a:ext cx="1351800" cy="276900"/>
          </a:xfrm>
          <a:prstGeom prst="rect">
            <a:avLst/>
          </a:prstGeom>
          <a:solidFill>
            <a:schemeClr val="lt1"/>
          </a:solidFill>
          <a:ln cap="flat" cmpd="sng" w="9525">
            <a:solidFill>
              <a:schemeClr val="lt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UY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mber/Mb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Google Shape;92;p1"/>
          <p:cNvSpPr/>
          <p:nvPr/>
        </p:nvSpPr>
        <p:spPr>
          <a:xfrm>
            <a:off x="6417382" y="2540391"/>
            <a:ext cx="110400" cy="1275600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1"/>
          <p:cNvSpPr/>
          <p:nvPr/>
        </p:nvSpPr>
        <p:spPr>
          <a:xfrm>
            <a:off x="10581089" y="2616590"/>
            <a:ext cx="110400" cy="1275600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94;p1"/>
          <p:cNvSpPr/>
          <p:nvPr/>
        </p:nvSpPr>
        <p:spPr>
          <a:xfrm>
            <a:off x="11033351" y="5432380"/>
            <a:ext cx="110400" cy="1275600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95;p1"/>
          <p:cNvSpPr/>
          <p:nvPr/>
        </p:nvSpPr>
        <p:spPr>
          <a:xfrm>
            <a:off x="5273471" y="5582392"/>
            <a:ext cx="110400" cy="1275600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6-13T16:15:40Z</dcterms:created>
  <dc:creator>Gonzalo Greif</dc:creator>
</cp:coreProperties>
</file>